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6" r:id="rId3"/>
    <p:sldId id="271" r:id="rId4"/>
    <p:sldId id="262" r:id="rId5"/>
    <p:sldId id="267" r:id="rId6"/>
    <p:sldId id="261" r:id="rId7"/>
    <p:sldId id="265" r:id="rId8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5" d="100"/>
          <a:sy n="65" d="100"/>
        </p:scale>
        <p:origin x="-108" y="-333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presProps" Target="presProps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1" Type="http://schemas.openxmlformats.org/officeDocument/2006/relationships/tableStyles" Target="tableStyles.xml"/><Relationship Id="rId10" Type="http://schemas.openxmlformats.org/officeDocument/2006/relationships/viewProps" Target="viewProps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7913D-FB52-4CD8-9828-1C469604E4E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1BAD-5733-47C9-8CC3-D5AFA8E25F5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7913D-FB52-4CD8-9828-1C469604E4E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1BAD-5733-47C9-8CC3-D5AFA8E25F5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7913D-FB52-4CD8-9828-1C469604E4E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1BAD-5733-47C9-8CC3-D5AFA8E25F5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7913D-FB52-4CD8-9828-1C469604E4E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1BAD-5733-47C9-8CC3-D5AFA8E25F5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7913D-FB52-4CD8-9828-1C469604E4E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1BAD-5733-47C9-8CC3-D5AFA8E25F5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7913D-FB52-4CD8-9828-1C469604E4E7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1BAD-5733-47C9-8CC3-D5AFA8E25F5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7913D-FB52-4CD8-9828-1C469604E4E7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1BAD-5733-47C9-8CC3-D5AFA8E25F5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7913D-FB52-4CD8-9828-1C469604E4E7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1BAD-5733-47C9-8CC3-D5AFA8E25F5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7913D-FB52-4CD8-9828-1C469604E4E7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1BAD-5733-47C9-8CC3-D5AFA8E25F5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7913D-FB52-4CD8-9828-1C469604E4E7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1BAD-5733-47C9-8CC3-D5AFA8E25F5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7913D-FB52-4CD8-9828-1C469604E4E7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1BAD-5733-47C9-8CC3-D5AFA8E25F5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57913D-FB52-4CD8-9828-1C469604E4E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A71BAD-5733-47C9-8CC3-D5AFA8E25F5B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3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4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405355" y="2712567"/>
            <a:ext cx="4904105" cy="27559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</a:pP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l Figure 3. The results of </a:t>
            </a:r>
            <a:r>
              <a:rPr kumimoji="0" lang="en-US" altLang="zh-CN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qRT</a:t>
            </a: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PCR for technical replication</a:t>
            </a:r>
            <a:endParaRPr kumimoji="0" lang="en-US" altLang="zh-CN" sz="105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4372168" y="263390"/>
            <a:ext cx="234134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l </a:t>
            </a:r>
            <a:r>
              <a:rPr lang="en-US" altLang="zh-CN" b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s</a:t>
            </a:r>
            <a:endParaRPr lang="zh-CN" altLang="en-US" dirty="0"/>
          </a:p>
        </p:txBody>
      </p:sp>
      <p:sp>
        <p:nvSpPr>
          <p:cNvPr id="7" name="Rectangle 1"/>
          <p:cNvSpPr>
            <a:spLocks noChangeArrowheads="1"/>
          </p:cNvSpPr>
          <p:nvPr/>
        </p:nvSpPr>
        <p:spPr bwMode="auto">
          <a:xfrm>
            <a:off x="405260" y="1905141"/>
            <a:ext cx="11381610" cy="6451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l Figure 2</a:t>
            </a:r>
            <a:r>
              <a:rPr lang="en-US" altLang="zh-CN" sz="1200" b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Volcano plot of </a:t>
            </a:r>
            <a:r>
              <a:rPr lang="en-US" altLang="zh-CN" sz="1200" b="1" dirty="0" err="1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iRNA</a:t>
            </a:r>
            <a:r>
              <a:rPr lang="en-US" altLang="zh-CN" sz="1200" b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expression in replication cohort (GSE95070). </a:t>
            </a:r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lotted along the x-axis is the mean of log2 fold-change, along the y-axis the negative logarithm of the log2 p values. </a:t>
            </a:r>
            <a:r>
              <a:rPr lang="en-US" altLang="zh-CN" sz="12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Lightblue</a:t>
            </a:r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demonstrates the </a:t>
            </a:r>
            <a:r>
              <a:rPr lang="en-US" altLang="zh-CN" sz="12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iRNAs</a:t>
            </a:r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with significant p value (p &lt; 0.05), and red denotes these significant </a:t>
            </a:r>
            <a:r>
              <a:rPr lang="en-US" altLang="zh-CN" sz="12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iRNAs</a:t>
            </a:r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validated by the replication cohort. The horizontal line represents the threshold of significant p value.</a:t>
            </a:r>
            <a:endParaRPr kumimoji="0" lang="en-US" altLang="zh-CN" sz="105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sp>
        <p:nvSpPr>
          <p:cNvPr id="9" name="Rectangle 1"/>
          <p:cNvSpPr>
            <a:spLocks noChangeArrowheads="1"/>
          </p:cNvSpPr>
          <p:nvPr/>
        </p:nvSpPr>
        <p:spPr bwMode="auto">
          <a:xfrm>
            <a:off x="412340" y="3149854"/>
            <a:ext cx="11573634" cy="82994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l Figure 4</a:t>
            </a:r>
            <a:r>
              <a:rPr lang="en-US" altLang="zh-CN" sz="1200" b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WGCNA module-based analysis for </a:t>
            </a:r>
            <a:r>
              <a:rPr lang="en-US" altLang="zh-CN" sz="12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es and </a:t>
            </a:r>
            <a:r>
              <a:rPr lang="en-US" altLang="zh-CN" sz="1200" dirty="0" err="1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iRNAs</a:t>
            </a:r>
            <a:r>
              <a:rPr lang="en-US" altLang="zh-CN" sz="12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expression data of GSE73507. The hierarchical clustering</a:t>
            </a:r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dendrogram</a:t>
            </a:r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is shown for </a:t>
            </a:r>
            <a:r>
              <a:rPr lang="en-US" altLang="zh-CN" sz="12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3,241 mRNAs and 546 </a:t>
            </a:r>
            <a:r>
              <a:rPr lang="en-US" altLang="zh-CN" sz="1200" dirty="0" err="1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iRNAs</a:t>
            </a:r>
            <a:r>
              <a:rPr lang="en-US" altLang="zh-CN" sz="12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expressed and highly connected genes. Each </a:t>
            </a:r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line </a:t>
            </a:r>
            <a:r>
              <a:rPr lang="en-US" altLang="zh-CN" sz="12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demonstrates a specific gene.</a:t>
            </a:r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Genes were clustered based on a dissimilarity measure (1-TOM). The branches are related to modules of highly interconnected gene groups. Below the </a:t>
            </a:r>
            <a:r>
              <a:rPr lang="en-US" altLang="zh-CN" sz="12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dendrogram</a:t>
            </a:r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of each gene group is a color to indicate its module color. </a:t>
            </a:r>
            <a:r>
              <a:rPr lang="en-US" altLang="zh-CN" sz="12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s </a:t>
            </a:r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 result, 25 co-expression module were constructed and painted with different colors</a:t>
            </a:r>
            <a:r>
              <a:rPr lang="en-US" altLang="zh-CN" sz="12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endParaRPr kumimoji="0" lang="en-US" altLang="zh-CN" sz="105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sp>
        <p:nvSpPr>
          <p:cNvPr id="10" name="矩形 9"/>
          <p:cNvSpPr/>
          <p:nvPr/>
        </p:nvSpPr>
        <p:spPr>
          <a:xfrm>
            <a:off x="434756" y="4065175"/>
            <a:ext cx="11116434" cy="6451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zh-CN" sz="1200" b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l Figure 5. KEGG pathway enrichment analyses for mmu-miR-190a-3p highly related genes in red module. </a:t>
            </a:r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 red vertical line indicates the threshold of the significant pathway enrichment p value after FDR correction. Dark blue color of horizontal bars represents the significantly enriched pathway, and the light blue color represents the non-significantly enriched pathway.</a:t>
            </a:r>
            <a:endParaRPr lang="zh-CN" altLang="zh-CN" sz="12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435105" y="1354596"/>
            <a:ext cx="11381610" cy="27559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spAutoFit/>
          </a:bodyPr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l Figure 1</a:t>
            </a:r>
            <a:r>
              <a:rPr lang="en-US" altLang="zh-CN" sz="1200" b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The detailed time line of the euthanization of study animals</a:t>
            </a:r>
            <a:endParaRPr kumimoji="0" lang="en-US" altLang="zh-CN" sz="105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0213848" y="6460488"/>
            <a:ext cx="1746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 dirty="0" smtClean="0"/>
              <a:t>Supplemental Figure 1</a:t>
            </a:r>
            <a:endParaRPr lang="zh-CN" altLang="en-US" sz="1200" b="1" dirty="0"/>
          </a:p>
        </p:txBody>
      </p:sp>
      <p:pic>
        <p:nvPicPr>
          <p:cNvPr id="2" name="图片 1" descr="无标题.png"/>
          <p:cNvPicPr/>
          <p:nvPr/>
        </p:nvPicPr>
        <p:blipFill>
          <a:blip r:embed="rId1"/>
          <a:stretch>
            <a:fillRect/>
          </a:stretch>
        </p:blipFill>
        <p:spPr>
          <a:xfrm>
            <a:off x="1831975" y="1477645"/>
            <a:ext cx="8272780" cy="3689985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6329" y="1384645"/>
            <a:ext cx="10294157" cy="410175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0213848" y="6460488"/>
            <a:ext cx="1746504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/>
              <a:t>Supplemental Figure 2</a:t>
            </a:r>
            <a:endParaRPr lang="zh-CN" altLang="en-US" sz="12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0213848" y="6460488"/>
            <a:ext cx="1746504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/>
              <a:t>Supplemental Figure </a:t>
            </a:r>
            <a:r>
              <a:rPr lang="en-US" altLang="zh-CN" sz="1200" b="1" dirty="0"/>
              <a:t>3</a:t>
            </a:r>
            <a:endParaRPr lang="zh-CN" altLang="en-US" sz="1200" b="1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87483" y="1082207"/>
            <a:ext cx="6859524" cy="43599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9530" y="1052428"/>
            <a:ext cx="10040751" cy="480127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0213848" y="6460488"/>
            <a:ext cx="1746504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/>
              <a:t>Supplemental Figure </a:t>
            </a:r>
            <a:r>
              <a:rPr lang="en-US" sz="1200" b="1" dirty="0" smtClean="0"/>
              <a:t>4</a:t>
            </a:r>
            <a:endParaRPr lang="en-US" sz="12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10213848" y="6460488"/>
            <a:ext cx="1746504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/>
              <a:t>Supplemental Figure 5</a:t>
            </a:r>
            <a:endParaRPr lang="zh-CN" altLang="en-US" sz="1200" b="1" dirty="0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834357" y="1947543"/>
            <a:ext cx="6523285" cy="2962913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56</Words>
  <Application>WPS 演示</Application>
  <PresentationFormat>自定义</PresentationFormat>
  <Paragraphs>22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5" baseType="lpstr">
      <vt:lpstr>Arial</vt:lpstr>
      <vt:lpstr>宋体</vt:lpstr>
      <vt:lpstr>Wingdings</vt:lpstr>
      <vt:lpstr>Times New Roman</vt:lpstr>
      <vt:lpstr>Calibri</vt:lpstr>
      <vt:lpstr>微软雅黑</vt:lpstr>
      <vt:lpstr>Arial Unicode MS</vt:lpstr>
      <vt:lpstr>Calibri Light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global</dc:creator>
  <cp:lastModifiedBy>云缘~</cp:lastModifiedBy>
  <cp:revision>69</cp:revision>
  <dcterms:created xsi:type="dcterms:W3CDTF">2018-05-12T15:12:00Z</dcterms:created>
  <dcterms:modified xsi:type="dcterms:W3CDTF">2019-08-08T02:56:2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8894</vt:lpwstr>
  </property>
</Properties>
</file>